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030A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1" autoAdjust="0"/>
    <p:restoredTop sz="94660"/>
  </p:normalViewPr>
  <p:slideViewPr>
    <p:cSldViewPr snapToGrid="0">
      <p:cViewPr>
        <p:scale>
          <a:sx n="135" d="100"/>
          <a:sy n="135" d="100"/>
        </p:scale>
        <p:origin x="-168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52F3C7B-568B-4C8A-BB80-D1A97A1A38D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888F9B3D-5ABE-4816-BD01-EABB9D32459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DE3220B-90D6-402B-B3A2-4B01312D46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5ADDB-E08B-4DF7-AB27-ED295A8AE611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2BF101C-5FC5-41F8-B099-941B936810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79F656C-97F6-4B4B-8669-E19DC6F3D8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098800-C5B4-47AF-8128-92777C41A5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925565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C60B9F3-2DCC-4E01-9239-675122B9C0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47E7BE77-8E4D-44D8-8B1B-A1F1FBAA1B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30B20C8-21E0-419D-9575-192D2261BE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5ADDB-E08B-4DF7-AB27-ED295A8AE611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B761337-4096-4F55-B8E8-564B168940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039FE01-8EFF-4B41-ADDD-C92029F55B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098800-C5B4-47AF-8128-92777C41A5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309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DCC43999-A6DC-49B2-92D9-C7D5CAEA8E7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D46349FF-9A4D-4389-AC36-3505242E96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55800CB-2F7B-4875-9DA7-BA69156B3B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5ADDB-E08B-4DF7-AB27-ED295A8AE611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C6F7715-029A-413E-954B-4F933CDB50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1FA5D33-B11A-4201-BE0E-D524F083B9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098800-C5B4-47AF-8128-92777C41A5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70580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D60329A-C3D7-480D-B376-29D26C541D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CACFC04-6ABB-40AF-9AAF-D8AA11E474C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C2613E4-DF6B-4A65-A904-D25441898A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5ADDB-E08B-4DF7-AB27-ED295A8AE611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2957A1B-FF39-4DDD-A3C7-E6400BEF30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E580AF5-6BEF-43E7-AA3A-ABDB3D5EF8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098800-C5B4-47AF-8128-92777C41A5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344585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7164E00-7196-48E2-AB20-8E015B156D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C6B58894-A586-4B87-A337-05123FC342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F4B4D46-F84D-437F-9FD9-79E971A196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5ADDB-E08B-4DF7-AB27-ED295A8AE611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4A3241F-7C9B-45DB-AE63-1BFC763FE1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FA09B8A-5F65-4599-9DA8-8A5D338E62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098800-C5B4-47AF-8128-92777C41A5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701625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6CE44B6-1362-421C-A42A-B43C15BC7E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0093DC37-90AC-4F15-BCCC-26D34961400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76FEC843-D7CE-400A-93EB-B5D73F5944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B7A303A-E7B7-463D-9942-18FAB1BCF2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5ADDB-E08B-4DF7-AB27-ED295A8AE611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1A231A6-F4A2-4D48-B74D-9464980920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B392AAD-B988-4EF8-978C-253F9513A7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098800-C5B4-47AF-8128-92777C41A5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626896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FF3E51C-39A2-4DE7-ABEF-66D7FF44D3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8C39D12-0B80-4B59-825D-12FB0CC84F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AA032E6-1B63-40AA-A9AE-DF15ADD282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87AEFFC5-30DD-4D76-9E58-3A10BE5A09B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952FDF3F-D53D-4EC3-96EE-C360939536B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FEFA9D18-06B5-4F8F-9CEC-B626937D81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5ADDB-E08B-4DF7-AB27-ED295A8AE611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7CB23427-4E9B-46DA-B382-38014FF603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46C51C41-B705-49A7-8E27-C61C96647E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098800-C5B4-47AF-8128-92777C41A5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836579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8FCE2C5-23F2-4357-B473-BA06B55DF0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126C2985-1605-4B05-9E8C-87D5DE74DB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5ADDB-E08B-4DF7-AB27-ED295A8AE611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8BD5B2AD-CF02-4FCC-AEED-1E3D08EC10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404D47A5-F08B-40C8-9E7B-24228EFCA4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098800-C5B4-47AF-8128-92777C41A5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249138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8068B963-2886-409C-9FC9-A3A14F4EB2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5ADDB-E08B-4DF7-AB27-ED295A8AE611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806570EA-B271-44B4-925A-ABA1A90742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4A9C4815-3A60-43C9-8989-2C30B65E79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098800-C5B4-47AF-8128-92777C41A5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58444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4247956-563F-4013-A65D-B2EAB5A5C1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873E2E9-5B30-41CC-8853-5320AB552F7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3B274019-C139-443D-8A14-A927FE561C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5E3D802-6CD5-4AC3-B367-230F5A2DEA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5ADDB-E08B-4DF7-AB27-ED295A8AE611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57973D0-6BF6-44FE-8F1D-7E99BD53E1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589A689-2243-4151-820E-A2BC1843F1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098800-C5B4-47AF-8128-92777C41A5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131271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4AD489E-BCBD-4F38-A238-090ACE9228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7CDA9B5B-3CF8-49DB-86CE-8E98261603B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941F9C4A-CB1B-4FF1-AB0F-386C9B37D1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048253EA-8A9B-404F-92B9-2FE39D980C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5ADDB-E08B-4DF7-AB27-ED295A8AE611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67CFDF8F-4762-48EF-8DD4-AC69513C02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3A027C6-C27E-4EB1-9099-F5A3B96763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098800-C5B4-47AF-8128-92777C41A5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999351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9E164E60-5E44-457B-8A94-5397B01047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A0CDF67-B0F4-4398-A6A7-3B5F288030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C73B336-5EB4-4ACC-9F78-8DFBDCE13E9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45ADDB-E08B-4DF7-AB27-ED295A8AE611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8C83678-7DE9-411F-BF76-F5355C4B552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BB51649-8475-4FBA-9DCA-0662E69E17A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098800-C5B4-47AF-8128-92777C41A5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629884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9B84511E-2AE0-417D-8E10-73D1E7E83A0A}"/>
              </a:ext>
            </a:extLst>
          </p:cNvPr>
          <p:cNvSpPr/>
          <p:nvPr/>
        </p:nvSpPr>
        <p:spPr>
          <a:xfrm>
            <a:off x="8967408" y="2251626"/>
            <a:ext cx="168751" cy="202051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" rtlCol="0" anchor="ctr"/>
          <a:lstStyle/>
          <a:p>
            <a:pPr algn="ctr"/>
            <a:r>
              <a:rPr lang="fr-FR" sz="1400" dirty="0" err="1">
                <a:solidFill>
                  <a:schemeClr val="tx1"/>
                </a:solidFill>
              </a:rPr>
              <a:t>Nucleotide</a:t>
            </a:r>
            <a:r>
              <a:rPr lang="fr-FR" sz="1400" dirty="0">
                <a:solidFill>
                  <a:schemeClr val="tx1"/>
                </a:solidFill>
              </a:rPr>
              <a:t> distance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8A46434B-323C-4CC7-BE2C-22A10B575BBF}"/>
              </a:ext>
            </a:extLst>
          </p:cNvPr>
          <p:cNvSpPr/>
          <p:nvPr/>
        </p:nvSpPr>
        <p:spPr>
          <a:xfrm>
            <a:off x="4200388" y="881216"/>
            <a:ext cx="3924447" cy="22773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i="1" dirty="0">
                <a:solidFill>
                  <a:schemeClr val="tx1"/>
                </a:solidFill>
              </a:rPr>
              <a:t>s-type </a:t>
            </a:r>
            <a:r>
              <a:rPr lang="fr-FR" i="1" dirty="0" err="1">
                <a:solidFill>
                  <a:schemeClr val="tx1"/>
                </a:solidFill>
              </a:rPr>
              <a:t>pyocin</a:t>
            </a:r>
            <a:r>
              <a:rPr lang="fr-FR" i="1" dirty="0">
                <a:solidFill>
                  <a:schemeClr val="tx1"/>
                </a:solidFill>
              </a:rPr>
              <a:t> </a:t>
            </a:r>
            <a:r>
              <a:rPr lang="fr-FR" dirty="0" err="1">
                <a:solidFill>
                  <a:schemeClr val="tx1"/>
                </a:solidFill>
              </a:rPr>
              <a:t>nucleotide</a:t>
            </a:r>
            <a:r>
              <a:rPr lang="fr-FR" dirty="0">
                <a:solidFill>
                  <a:schemeClr val="tx1"/>
                </a:solidFill>
              </a:rPr>
              <a:t> distance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F622D33F-FE6E-4E78-8C5E-C6848555960D}"/>
              </a:ext>
            </a:extLst>
          </p:cNvPr>
          <p:cNvSpPr/>
          <p:nvPr/>
        </p:nvSpPr>
        <p:spPr>
          <a:xfrm>
            <a:off x="4317664" y="1301960"/>
            <a:ext cx="3924447" cy="393010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7" name="Connecteur droit avec flèche 6">
            <a:extLst>
              <a:ext uri="{FF2B5EF4-FFF2-40B4-BE49-F238E27FC236}">
                <a16:creationId xmlns:a16="http://schemas.microsoft.com/office/drawing/2014/main" id="{53A7EAD3-F64E-44A7-B2E9-4822D4695874}"/>
              </a:ext>
            </a:extLst>
          </p:cNvPr>
          <p:cNvCxnSpPr>
            <a:cxnSpLocks/>
          </p:cNvCxnSpPr>
          <p:nvPr/>
        </p:nvCxnSpPr>
        <p:spPr>
          <a:xfrm flipV="1">
            <a:off x="3348763" y="4779405"/>
            <a:ext cx="968901" cy="16198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Image 2">
            <a:extLst>
              <a:ext uri="{FF2B5EF4-FFF2-40B4-BE49-F238E27FC236}">
                <a16:creationId xmlns:a16="http://schemas.microsoft.com/office/drawing/2014/main" id="{92FBAA75-DA61-400B-B665-5E3BBAE7C06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6506" y="476118"/>
            <a:ext cx="6172212" cy="6172212"/>
          </a:xfrm>
          <a:prstGeom prst="rect">
            <a:avLst/>
          </a:prstGeom>
        </p:spPr>
      </p:pic>
      <p:grpSp>
        <p:nvGrpSpPr>
          <p:cNvPr id="12" name="Groupe 11">
            <a:extLst>
              <a:ext uri="{FF2B5EF4-FFF2-40B4-BE49-F238E27FC236}">
                <a16:creationId xmlns:a16="http://schemas.microsoft.com/office/drawing/2014/main" id="{84082DC7-7655-48F9-A2E4-FE4902F1E536}"/>
              </a:ext>
            </a:extLst>
          </p:cNvPr>
          <p:cNvGrpSpPr/>
          <p:nvPr/>
        </p:nvGrpSpPr>
        <p:grpSpPr>
          <a:xfrm>
            <a:off x="4156363" y="5232055"/>
            <a:ext cx="4085748" cy="942117"/>
            <a:chOff x="4156363" y="5232055"/>
            <a:chExt cx="4085748" cy="942117"/>
          </a:xfrm>
        </p:grpSpPr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C8E8798D-CDC3-4C89-B79D-156E6C6EA748}"/>
                </a:ext>
              </a:extLst>
            </p:cNvPr>
            <p:cNvSpPr/>
            <p:nvPr/>
          </p:nvSpPr>
          <p:spPr>
            <a:xfrm flipV="1">
              <a:off x="4156363" y="5232061"/>
              <a:ext cx="161301" cy="942111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EC9F6DFC-D322-4F95-8F41-4CA30A26A564}"/>
                </a:ext>
              </a:extLst>
            </p:cNvPr>
            <p:cNvSpPr/>
            <p:nvPr/>
          </p:nvSpPr>
          <p:spPr>
            <a:xfrm flipV="1">
              <a:off x="4317665" y="5232059"/>
              <a:ext cx="3180416" cy="942111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917015D2-41CC-497E-89A0-9B72C9754393}"/>
                </a:ext>
              </a:extLst>
            </p:cNvPr>
            <p:cNvSpPr/>
            <p:nvPr/>
          </p:nvSpPr>
          <p:spPr>
            <a:xfrm flipV="1">
              <a:off x="7498081" y="5232055"/>
              <a:ext cx="744030" cy="942111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13" name="Groupe 12">
            <a:extLst>
              <a:ext uri="{FF2B5EF4-FFF2-40B4-BE49-F238E27FC236}">
                <a16:creationId xmlns:a16="http://schemas.microsoft.com/office/drawing/2014/main" id="{403F04DC-041F-42D1-9BD6-3BB247EA26C2}"/>
              </a:ext>
            </a:extLst>
          </p:cNvPr>
          <p:cNvGrpSpPr/>
          <p:nvPr/>
        </p:nvGrpSpPr>
        <p:grpSpPr>
          <a:xfrm rot="5400000">
            <a:off x="1643399" y="2718123"/>
            <a:ext cx="4085748" cy="942117"/>
            <a:chOff x="4156363" y="5232055"/>
            <a:chExt cx="4085748" cy="942117"/>
          </a:xfrm>
        </p:grpSpPr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38686489-E07C-4652-B047-38BAFB61E8D9}"/>
                </a:ext>
              </a:extLst>
            </p:cNvPr>
            <p:cNvSpPr/>
            <p:nvPr/>
          </p:nvSpPr>
          <p:spPr>
            <a:xfrm flipV="1">
              <a:off x="4156363" y="5232061"/>
              <a:ext cx="161301" cy="942111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41ECDAB4-9ECC-40C8-A4AD-36AE42019218}"/>
                </a:ext>
              </a:extLst>
            </p:cNvPr>
            <p:cNvSpPr/>
            <p:nvPr/>
          </p:nvSpPr>
          <p:spPr>
            <a:xfrm flipV="1">
              <a:off x="4317665" y="5232059"/>
              <a:ext cx="3180416" cy="942111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8CDA2C47-A9F4-470D-876E-9421DD0F0129}"/>
                </a:ext>
              </a:extLst>
            </p:cNvPr>
            <p:cNvSpPr/>
            <p:nvPr/>
          </p:nvSpPr>
          <p:spPr>
            <a:xfrm flipV="1">
              <a:off x="7498081" y="5232055"/>
              <a:ext cx="744030" cy="942111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8" name="ZoneTexte 7">
            <a:extLst>
              <a:ext uri="{FF2B5EF4-FFF2-40B4-BE49-F238E27FC236}">
                <a16:creationId xmlns:a16="http://schemas.microsoft.com/office/drawing/2014/main" id="{3AE544AA-60EE-478A-9A7C-0994F183F15F}"/>
              </a:ext>
            </a:extLst>
          </p:cNvPr>
          <p:cNvSpPr txBox="1"/>
          <p:nvPr/>
        </p:nvSpPr>
        <p:spPr>
          <a:xfrm>
            <a:off x="2207924" y="5194382"/>
            <a:ext cx="1429128" cy="12311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i="1" dirty="0"/>
              <a:t>s-type pyocin</a:t>
            </a:r>
            <a:r>
              <a:rPr lang="fr-FR" sz="1600" b="1" dirty="0"/>
              <a:t>_M1</a:t>
            </a:r>
          </a:p>
          <a:p>
            <a:pPr algn="ctr"/>
            <a:r>
              <a:rPr lang="fr-FR" sz="1400" dirty="0"/>
              <a:t>% of </a:t>
            </a:r>
            <a:r>
              <a:rPr lang="fr-FR" sz="1400" dirty="0" err="1"/>
              <a:t>identity</a:t>
            </a:r>
            <a:r>
              <a:rPr lang="fr-FR" sz="1400" dirty="0"/>
              <a:t>  Max-Min</a:t>
            </a:r>
          </a:p>
          <a:p>
            <a:pPr algn="ctr"/>
            <a:r>
              <a:rPr lang="fr-FR" sz="1400" dirty="0"/>
              <a:t>[100-68%]</a:t>
            </a:r>
          </a:p>
        </p:txBody>
      </p:sp>
      <p:cxnSp>
        <p:nvCxnSpPr>
          <p:cNvPr id="18" name="Connecteur droit avec flèche 17">
            <a:extLst>
              <a:ext uri="{FF2B5EF4-FFF2-40B4-BE49-F238E27FC236}">
                <a16:creationId xmlns:a16="http://schemas.microsoft.com/office/drawing/2014/main" id="{9E1C7085-936C-4A1B-9202-FC2F2DAC3862}"/>
              </a:ext>
            </a:extLst>
          </p:cNvPr>
          <p:cNvCxnSpPr>
            <a:cxnSpLocks/>
          </p:cNvCxnSpPr>
          <p:nvPr/>
        </p:nvCxnSpPr>
        <p:spPr>
          <a:xfrm flipV="1">
            <a:off x="3348763" y="5086468"/>
            <a:ext cx="968900" cy="32959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0" name="Groupe 19">
            <a:extLst>
              <a:ext uri="{FF2B5EF4-FFF2-40B4-BE49-F238E27FC236}">
                <a16:creationId xmlns:a16="http://schemas.microsoft.com/office/drawing/2014/main" id="{9109BD6F-88E7-4558-BAEE-FA930935CCC1}"/>
              </a:ext>
            </a:extLst>
          </p:cNvPr>
          <p:cNvGrpSpPr/>
          <p:nvPr/>
        </p:nvGrpSpPr>
        <p:grpSpPr>
          <a:xfrm>
            <a:off x="9344212" y="273739"/>
            <a:ext cx="2973294" cy="941438"/>
            <a:chOff x="9344212" y="273739"/>
            <a:chExt cx="2973294" cy="941438"/>
          </a:xfrm>
        </p:grpSpPr>
        <p:sp>
          <p:nvSpPr>
            <p:cNvPr id="21" name="ZoneTexte 20">
              <a:extLst>
                <a:ext uri="{FF2B5EF4-FFF2-40B4-BE49-F238E27FC236}">
                  <a16:creationId xmlns:a16="http://schemas.microsoft.com/office/drawing/2014/main" id="{C47EDE1D-CBCA-4400-A114-38DE006F6D35}"/>
                </a:ext>
              </a:extLst>
            </p:cNvPr>
            <p:cNvSpPr txBox="1"/>
            <p:nvPr/>
          </p:nvSpPr>
          <p:spPr>
            <a:xfrm>
              <a:off x="9705788" y="273739"/>
              <a:ext cx="235093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i="1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M. morganii</a:t>
              </a:r>
              <a:r>
                <a:rPr lang="en-US" sz="14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 subsp. </a:t>
              </a:r>
              <a:r>
                <a:rPr lang="en-US" sz="1400" i="1" dirty="0">
                  <a:solidFill>
                    <a:srgbClr val="1F1F1F"/>
                  </a:solidFill>
                  <a:ea typeface="Times New Roman" panose="02020603050405020304" pitchFamily="18" charset="0"/>
                </a:rPr>
                <a:t>morganii</a:t>
              </a:r>
              <a:endParaRPr lang="fr-FR" sz="1400" dirty="0"/>
            </a:p>
          </p:txBody>
        </p:sp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9974840E-D8C3-48F9-B18F-0B56C63535A7}"/>
                </a:ext>
              </a:extLst>
            </p:cNvPr>
            <p:cNvSpPr txBox="1"/>
            <p:nvPr/>
          </p:nvSpPr>
          <p:spPr>
            <a:xfrm>
              <a:off x="9705788" y="609776"/>
              <a:ext cx="261171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i="1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M. morganii</a:t>
              </a:r>
              <a:r>
                <a:rPr lang="en-US" sz="14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 subsp. </a:t>
              </a:r>
              <a:r>
                <a:rPr lang="en-US" sz="1400" i="1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intermedius</a:t>
              </a:r>
              <a:endParaRPr lang="fr-FR" sz="1400" i="1" dirty="0"/>
            </a:p>
          </p:txBody>
        </p:sp>
        <p:sp>
          <p:nvSpPr>
            <p:cNvPr id="23" name="ZoneTexte 22">
              <a:extLst>
                <a:ext uri="{FF2B5EF4-FFF2-40B4-BE49-F238E27FC236}">
                  <a16:creationId xmlns:a16="http://schemas.microsoft.com/office/drawing/2014/main" id="{47717312-4AAC-4FAF-8528-064F80434608}"/>
                </a:ext>
              </a:extLst>
            </p:cNvPr>
            <p:cNvSpPr txBox="1"/>
            <p:nvPr/>
          </p:nvSpPr>
          <p:spPr>
            <a:xfrm>
              <a:off x="9705788" y="907400"/>
              <a:ext cx="261171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i="1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M. </a:t>
              </a:r>
              <a:r>
                <a:rPr lang="en-US" sz="1400" i="1" dirty="0" err="1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sibonii</a:t>
              </a:r>
              <a:endParaRPr lang="fr-FR" sz="1400" dirty="0"/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5F2E2E8C-0F36-4C71-9E85-F26B801FD7A0}"/>
                </a:ext>
              </a:extLst>
            </p:cNvPr>
            <p:cNvSpPr/>
            <p:nvPr/>
          </p:nvSpPr>
          <p:spPr>
            <a:xfrm>
              <a:off x="9357375" y="962486"/>
              <a:ext cx="348413" cy="234709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95B0FA61-ABAB-48EA-A69E-69AA2BC89B06}"/>
                </a:ext>
              </a:extLst>
            </p:cNvPr>
            <p:cNvSpPr/>
            <p:nvPr/>
          </p:nvSpPr>
          <p:spPr>
            <a:xfrm>
              <a:off x="9357375" y="625609"/>
              <a:ext cx="348413" cy="234709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213D6C40-DEEF-428D-AF3A-14DA2B99724B}"/>
                </a:ext>
              </a:extLst>
            </p:cNvPr>
            <p:cNvSpPr/>
            <p:nvPr/>
          </p:nvSpPr>
          <p:spPr>
            <a:xfrm>
              <a:off x="9344212" y="310272"/>
              <a:ext cx="348413" cy="234709"/>
            </a:xfrm>
            <a:prstGeom prst="rect">
              <a:avLst/>
            </a:prstGeom>
            <a:solidFill>
              <a:schemeClr val="accent6">
                <a:alpha val="50196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11" name="Rectangle 10">
            <a:extLst>
              <a:ext uri="{FF2B5EF4-FFF2-40B4-BE49-F238E27FC236}">
                <a16:creationId xmlns:a16="http://schemas.microsoft.com/office/drawing/2014/main" id="{80C1CC27-243B-DDE5-F0EA-AA8AB37C6AA7}"/>
              </a:ext>
            </a:extLst>
          </p:cNvPr>
          <p:cNvSpPr/>
          <p:nvPr/>
        </p:nvSpPr>
        <p:spPr>
          <a:xfrm>
            <a:off x="4310743" y="1301960"/>
            <a:ext cx="3941642" cy="393009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328181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2</TotalTime>
  <Words>32</Words>
  <Application>Microsoft Macintosh PowerPoint</Application>
  <PresentationFormat>Grand écran</PresentationFormat>
  <Paragraphs>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thilde Duque</dc:creator>
  <cp:lastModifiedBy>DORTET Laurent</cp:lastModifiedBy>
  <cp:revision>9</cp:revision>
  <dcterms:created xsi:type="dcterms:W3CDTF">2025-09-17T12:14:37Z</dcterms:created>
  <dcterms:modified xsi:type="dcterms:W3CDTF">2025-12-24T14:08:01Z</dcterms:modified>
</cp:coreProperties>
</file>